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435" r:id="rId3"/>
    <p:sldId id="436" r:id="rId4"/>
    <p:sldId id="43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6F5328-998D-41F1-8022-B2C0E372E8C9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36DE46-187B-4B2A-9B3E-826EA1494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134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36DE46-187B-4B2A-9B3E-826EA149484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279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99700-0F8E-632D-82F2-07C73C9B61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2CEACC-C353-2DB3-2D0B-353110B891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BBB724-FC78-C15A-8F0F-D42A638E9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0F8844-C364-C0D0-9571-C06B51BC0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FB09A-343C-7648-661A-2DBAA5823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216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AB1991-A367-85D0-F6B0-E2A269CDFE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75B71F-3440-8310-ACE1-0455A27EC9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20D7BC-803B-BB6B-C4B6-179498FC2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64D95A-AC50-B587-7A36-06397BEB5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B8075-106C-AFAF-4887-F2E094624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13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847289-AB6E-F9CF-0460-23A932DF6D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E96EDB-BF32-79A1-74A0-321029DF73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DC585F-9C43-2A03-CBCC-70C9350F2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ED2C84-4BBE-3BF4-F65B-86ADB5504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5FE9E0-7452-235C-AC4E-D7B990206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3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3199F-AEF8-B4EC-5901-E6BE992852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A65C91-E7C6-074B-07B0-A21AAB9369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ACD6D-C139-6BC4-B2E9-E3E4C27D7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E5E16A-073A-7C73-5261-1B0F3F36C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FBECC9-9634-506E-2009-6CB0B00D2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406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382E2-1E1D-0BB6-FB06-2B5EA0396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853932-E716-30C2-BCC1-B1BD870DF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BE27B-7B2A-29E8-17B2-CD28F4C03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E5430F-CE98-209D-6845-EA6941467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B71FC4-7884-C447-F48E-7391641E4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15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2480F-9C43-F47D-7823-A0F5A24BF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63CF71-84FA-7A29-4BBC-B1321FF96C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6DC73C-2013-10CB-7188-9CC90444D8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877B2B-ACE5-ACA5-3D6E-5CF4205CB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D275E9-FE95-000A-4AAF-D23D8445D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8D7D60-FB54-85AD-0244-D6F0F63B5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869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E9A12-AB40-AF78-7C67-A380B35A23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5610FF-B639-A0B4-7364-0844B5C0FB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5B8DAA-30C8-088C-DD32-0F595B0880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503092-610F-8F91-7A72-0A16CD607F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A55C84-83E9-EC92-E3DF-0077FBB92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8B3F38C-89C3-34F7-8587-CF9EACDE8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02EE13-190D-E2A8-1A6F-58BB2E458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FB9EA9-EE84-6A66-19B7-0D5622C3E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129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30A31F-4200-33E8-C452-4EF1B2FE6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6D3C64-0960-D6EC-DE86-45D5944A8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1D2860-2E63-44E2-A9FE-964120A9A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F81E81-BC03-29A2-1FD9-7234FD81B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403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71EE91-0592-26D5-AC7E-768ED9ED2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8B98F2-600F-0263-9808-B92466144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ADB6C0-709B-B73F-BB39-7B66F7CCA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380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05C1E-009C-ADD3-88C0-3C3F52EDBF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9D05B4-F3FF-65E6-A15F-9034099756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E85CAB-A936-B421-E968-890062A49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502C04-1B3B-1642-2939-B754E70FB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F5FC8E-129D-2469-0373-16AF364B1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A01960-63F7-E02A-3586-4B9DDBD37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88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E38D47-8BD4-B8A0-D826-D712FB253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814523-399D-42F4-2102-FD41F8D29A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B0DF47-A20C-B242-AB95-5740267429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65F1C4-D769-4265-F225-F02C553BF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B40AEC-1CD6-E249-5142-612F1F4B3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7AD1DC-08D5-9EFA-D3E3-2835FFE73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168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4A34C0-05C6-0B4D-7D87-1D0CA0F007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E2731D-84CF-6B54-CAC5-1462EE8FC7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93EAC1-F2BD-2078-C6C7-B5716759AA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FFF265-3139-40E7-8CC9-13E56191E66B}" type="datetimeFigureOut">
              <a:rPr lang="en-US" smtClean="0"/>
              <a:t>7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0D6C2-C59F-C672-777D-27A6AB507D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DEEC2B-DA83-C482-213F-5542116CC3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DF6C8D-5914-4BE2-B739-76759801B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153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D4A1DF9-A5CF-776B-71E8-0AE5645951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96" t="6498" r="65955" b="24930"/>
          <a:stretch/>
        </p:blipFill>
        <p:spPr>
          <a:xfrm>
            <a:off x="568734" y="622673"/>
            <a:ext cx="8819280" cy="612582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085E327-194B-2248-73B1-BBF39370C9BB}"/>
              </a:ext>
            </a:extLst>
          </p:cNvPr>
          <p:cNvSpPr txBox="1"/>
          <p:nvPr/>
        </p:nvSpPr>
        <p:spPr>
          <a:xfrm>
            <a:off x="642988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F1CCDD2-869F-7145-D7A0-4C8403647AC0}"/>
              </a:ext>
            </a:extLst>
          </p:cNvPr>
          <p:cNvSpPr txBox="1"/>
          <p:nvPr/>
        </p:nvSpPr>
        <p:spPr>
          <a:xfrm>
            <a:off x="349904" y="926327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D464BB-E857-4FDA-CD83-D7BBEBA0AA5F}"/>
              </a:ext>
            </a:extLst>
          </p:cNvPr>
          <p:cNvSpPr txBox="1"/>
          <p:nvPr/>
        </p:nvSpPr>
        <p:spPr>
          <a:xfrm>
            <a:off x="1014211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74F43A-6A6C-EA58-F082-76B8BBE50D81}"/>
              </a:ext>
            </a:extLst>
          </p:cNvPr>
          <p:cNvSpPr txBox="1"/>
          <p:nvPr/>
        </p:nvSpPr>
        <p:spPr>
          <a:xfrm>
            <a:off x="3211949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791037-A8FB-0728-0955-31F2028527FC}"/>
              </a:ext>
            </a:extLst>
          </p:cNvPr>
          <p:cNvSpPr txBox="1"/>
          <p:nvPr/>
        </p:nvSpPr>
        <p:spPr>
          <a:xfrm>
            <a:off x="3507325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145FE7-340A-63C6-EB1E-0054A78133DE}"/>
              </a:ext>
            </a:extLst>
          </p:cNvPr>
          <p:cNvSpPr txBox="1"/>
          <p:nvPr/>
        </p:nvSpPr>
        <p:spPr>
          <a:xfrm>
            <a:off x="3763622" y="404712"/>
            <a:ext cx="371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4E8684-2A0D-A622-77D2-54BCCE0ED279}"/>
              </a:ext>
            </a:extLst>
          </p:cNvPr>
          <p:cNvSpPr txBox="1"/>
          <p:nvPr/>
        </p:nvSpPr>
        <p:spPr>
          <a:xfrm>
            <a:off x="4134857" y="404712"/>
            <a:ext cx="3712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01F31D-E9E4-FD69-B314-12D46CB1BC8C}"/>
              </a:ext>
            </a:extLst>
          </p:cNvPr>
          <p:cNvSpPr txBox="1"/>
          <p:nvPr/>
        </p:nvSpPr>
        <p:spPr>
          <a:xfrm>
            <a:off x="4536204" y="404712"/>
            <a:ext cx="347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BA5085C-7C6B-1FFC-D262-2A38828C7CE3}"/>
              </a:ext>
            </a:extLst>
          </p:cNvPr>
          <p:cNvSpPr txBox="1"/>
          <p:nvPr/>
        </p:nvSpPr>
        <p:spPr>
          <a:xfrm>
            <a:off x="4903063" y="404712"/>
            <a:ext cx="3790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DE08BD-A2A5-D395-DC5E-79D683154F2C}"/>
              </a:ext>
            </a:extLst>
          </p:cNvPr>
          <p:cNvSpPr txBox="1"/>
          <p:nvPr/>
        </p:nvSpPr>
        <p:spPr>
          <a:xfrm>
            <a:off x="5309006" y="404712"/>
            <a:ext cx="3790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62FDDE0-6843-F32D-0BCF-DD6CD4C9EFAA}"/>
              </a:ext>
            </a:extLst>
          </p:cNvPr>
          <p:cNvSpPr txBox="1"/>
          <p:nvPr/>
        </p:nvSpPr>
        <p:spPr>
          <a:xfrm>
            <a:off x="5700464" y="404712"/>
            <a:ext cx="347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0BF048-70E0-619A-C136-058233456EB6}"/>
              </a:ext>
            </a:extLst>
          </p:cNvPr>
          <p:cNvSpPr txBox="1"/>
          <p:nvPr/>
        </p:nvSpPr>
        <p:spPr>
          <a:xfrm>
            <a:off x="2549026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6B528F-4359-CE2D-20EE-5BF05EE14EE9}"/>
              </a:ext>
            </a:extLst>
          </p:cNvPr>
          <p:cNvSpPr txBox="1"/>
          <p:nvPr/>
        </p:nvSpPr>
        <p:spPr>
          <a:xfrm>
            <a:off x="6036520" y="404712"/>
            <a:ext cx="347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959836B-FB4A-4B12-8639-D1EDF51E0D7A}"/>
              </a:ext>
            </a:extLst>
          </p:cNvPr>
          <p:cNvSpPr txBox="1"/>
          <p:nvPr/>
        </p:nvSpPr>
        <p:spPr>
          <a:xfrm>
            <a:off x="1440163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97D25C-E552-05CB-9163-8D1AE3CF7DAB}"/>
              </a:ext>
            </a:extLst>
          </p:cNvPr>
          <p:cNvSpPr txBox="1"/>
          <p:nvPr/>
        </p:nvSpPr>
        <p:spPr>
          <a:xfrm>
            <a:off x="6400629" y="404712"/>
            <a:ext cx="347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F6B421D-AECF-5034-DC16-F09627F91995}"/>
              </a:ext>
            </a:extLst>
          </p:cNvPr>
          <p:cNvSpPr txBox="1"/>
          <p:nvPr/>
        </p:nvSpPr>
        <p:spPr>
          <a:xfrm>
            <a:off x="6746357" y="404712"/>
            <a:ext cx="343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27CDB8-D2AE-A0A8-6EAE-80E87A6F4661}"/>
              </a:ext>
            </a:extLst>
          </p:cNvPr>
          <p:cNvSpPr txBox="1"/>
          <p:nvPr/>
        </p:nvSpPr>
        <p:spPr>
          <a:xfrm>
            <a:off x="1871846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F2D3FB-A259-C86E-10C5-EB8DACA7705F}"/>
              </a:ext>
            </a:extLst>
          </p:cNvPr>
          <p:cNvSpPr txBox="1"/>
          <p:nvPr/>
        </p:nvSpPr>
        <p:spPr>
          <a:xfrm>
            <a:off x="7079198" y="404712"/>
            <a:ext cx="3556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A206753-316D-2732-E2C8-CE36202E65E8}"/>
              </a:ext>
            </a:extLst>
          </p:cNvPr>
          <p:cNvSpPr txBox="1"/>
          <p:nvPr/>
        </p:nvSpPr>
        <p:spPr>
          <a:xfrm>
            <a:off x="7533183" y="404712"/>
            <a:ext cx="339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4398665-6B84-8672-6222-FD757B66E4F6}"/>
              </a:ext>
            </a:extLst>
          </p:cNvPr>
          <p:cNvSpPr txBox="1"/>
          <p:nvPr/>
        </p:nvSpPr>
        <p:spPr>
          <a:xfrm>
            <a:off x="2862558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5DBC635-1150-F30D-F0DC-62F8A4D20C6E}"/>
              </a:ext>
            </a:extLst>
          </p:cNvPr>
          <p:cNvSpPr txBox="1"/>
          <p:nvPr/>
        </p:nvSpPr>
        <p:spPr>
          <a:xfrm>
            <a:off x="7937190" y="404712"/>
            <a:ext cx="3556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D1C3042-9A35-73D0-A541-D7DE79F70437}"/>
              </a:ext>
            </a:extLst>
          </p:cNvPr>
          <p:cNvSpPr txBox="1"/>
          <p:nvPr/>
        </p:nvSpPr>
        <p:spPr>
          <a:xfrm>
            <a:off x="8273107" y="404712"/>
            <a:ext cx="339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91237A-5935-1587-4645-567858585D7A}"/>
              </a:ext>
            </a:extLst>
          </p:cNvPr>
          <p:cNvSpPr txBox="1"/>
          <p:nvPr/>
        </p:nvSpPr>
        <p:spPr>
          <a:xfrm>
            <a:off x="2215720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F1BB5D9-E4F0-48B8-8AFD-39AD5C1BDFC6}"/>
              </a:ext>
            </a:extLst>
          </p:cNvPr>
          <p:cNvSpPr txBox="1"/>
          <p:nvPr/>
        </p:nvSpPr>
        <p:spPr>
          <a:xfrm>
            <a:off x="8641804" y="40471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63B53B7-8C91-0C40-4ABC-0DD3708AF56B}"/>
              </a:ext>
            </a:extLst>
          </p:cNvPr>
          <p:cNvSpPr txBox="1"/>
          <p:nvPr/>
        </p:nvSpPr>
        <p:spPr>
          <a:xfrm>
            <a:off x="8948101" y="404712"/>
            <a:ext cx="456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996AF2D-3279-D709-46EB-F74FD724A519}"/>
              </a:ext>
            </a:extLst>
          </p:cNvPr>
          <p:cNvSpPr txBox="1"/>
          <p:nvPr/>
        </p:nvSpPr>
        <p:spPr>
          <a:xfrm>
            <a:off x="349904" y="1284581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6E874D-83CE-5ED0-1F77-F263FB80A7D0}"/>
              </a:ext>
            </a:extLst>
          </p:cNvPr>
          <p:cNvSpPr txBox="1"/>
          <p:nvPr/>
        </p:nvSpPr>
        <p:spPr>
          <a:xfrm>
            <a:off x="349904" y="1758101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7013D70-7224-FE1E-A5B9-8667FA312D31}"/>
              </a:ext>
            </a:extLst>
          </p:cNvPr>
          <p:cNvSpPr txBox="1"/>
          <p:nvPr/>
        </p:nvSpPr>
        <p:spPr>
          <a:xfrm>
            <a:off x="349904" y="2158757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A54B15E-D944-56ED-C932-3550DB71AB47}"/>
              </a:ext>
            </a:extLst>
          </p:cNvPr>
          <p:cNvSpPr txBox="1"/>
          <p:nvPr/>
        </p:nvSpPr>
        <p:spPr>
          <a:xfrm>
            <a:off x="349904" y="2510448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1E3288D-0F3C-278D-4CFC-04F9CBF326D7}"/>
              </a:ext>
            </a:extLst>
          </p:cNvPr>
          <p:cNvSpPr txBox="1"/>
          <p:nvPr/>
        </p:nvSpPr>
        <p:spPr>
          <a:xfrm>
            <a:off x="349904" y="2880069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B9DC5A1-964D-0BAC-4CE2-94D3FEBE7274}"/>
              </a:ext>
            </a:extLst>
          </p:cNvPr>
          <p:cNvSpPr txBox="1"/>
          <p:nvPr/>
        </p:nvSpPr>
        <p:spPr>
          <a:xfrm>
            <a:off x="349904" y="3348994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4C87816-332A-75C7-3C44-1AF792FC101F}"/>
              </a:ext>
            </a:extLst>
          </p:cNvPr>
          <p:cNvSpPr txBox="1"/>
          <p:nvPr/>
        </p:nvSpPr>
        <p:spPr>
          <a:xfrm>
            <a:off x="349904" y="3769875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F1A3C80-AF31-7D47-4062-1D82067C72FB}"/>
              </a:ext>
            </a:extLst>
          </p:cNvPr>
          <p:cNvSpPr txBox="1"/>
          <p:nvPr/>
        </p:nvSpPr>
        <p:spPr>
          <a:xfrm>
            <a:off x="357719" y="4299252"/>
            <a:ext cx="211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D9EB57D-8762-7016-764D-9F16C33DBB25}"/>
              </a:ext>
            </a:extLst>
          </p:cNvPr>
          <p:cNvSpPr txBox="1"/>
          <p:nvPr/>
        </p:nvSpPr>
        <p:spPr>
          <a:xfrm>
            <a:off x="285426" y="4732320"/>
            <a:ext cx="371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60AB10C-7AC0-504C-B152-B924EC9F3E2E}"/>
              </a:ext>
            </a:extLst>
          </p:cNvPr>
          <p:cNvSpPr txBox="1"/>
          <p:nvPr/>
        </p:nvSpPr>
        <p:spPr>
          <a:xfrm>
            <a:off x="293242" y="5087231"/>
            <a:ext cx="3712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6AB133E-E264-82FF-0DFF-84E57C4272E7}"/>
              </a:ext>
            </a:extLst>
          </p:cNvPr>
          <p:cNvSpPr txBox="1"/>
          <p:nvPr/>
        </p:nvSpPr>
        <p:spPr>
          <a:xfrm>
            <a:off x="281525" y="5398696"/>
            <a:ext cx="347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32F4BFC-E569-103B-693B-D0311D2321B2}"/>
              </a:ext>
            </a:extLst>
          </p:cNvPr>
          <p:cNvSpPr txBox="1"/>
          <p:nvPr/>
        </p:nvSpPr>
        <p:spPr>
          <a:xfrm>
            <a:off x="273705" y="5836358"/>
            <a:ext cx="3790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51285A9-E8F3-3F31-4897-4FCD06C88EAD}"/>
              </a:ext>
            </a:extLst>
          </p:cNvPr>
          <p:cNvSpPr txBox="1"/>
          <p:nvPr/>
        </p:nvSpPr>
        <p:spPr>
          <a:xfrm>
            <a:off x="281520" y="6185751"/>
            <a:ext cx="3790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A4D4FAD-B91B-B419-F3CE-604D8FA730F1}"/>
              </a:ext>
            </a:extLst>
          </p:cNvPr>
          <p:cNvSpPr txBox="1"/>
          <p:nvPr/>
        </p:nvSpPr>
        <p:spPr>
          <a:xfrm>
            <a:off x="281525" y="6530777"/>
            <a:ext cx="347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B6B4B32-BA29-483F-CE6F-EF5B05645800}"/>
              </a:ext>
            </a:extLst>
          </p:cNvPr>
          <p:cNvSpPr txBox="1"/>
          <p:nvPr/>
        </p:nvSpPr>
        <p:spPr>
          <a:xfrm>
            <a:off x="3518246" y="109499"/>
            <a:ext cx="3588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hromosome number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E0EF73-2EBB-E421-5BD1-2FE3D235CE47}"/>
              </a:ext>
            </a:extLst>
          </p:cNvPr>
          <p:cNvSpPr txBox="1"/>
          <p:nvPr/>
        </p:nvSpPr>
        <p:spPr>
          <a:xfrm rot="16200000">
            <a:off x="-233629" y="3577174"/>
            <a:ext cx="80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D4C0646A-8110-1671-39A1-34EB42ED442B}"/>
              </a:ext>
            </a:extLst>
          </p:cNvPr>
          <p:cNvSpPr/>
          <p:nvPr/>
        </p:nvSpPr>
        <p:spPr>
          <a:xfrm>
            <a:off x="560918" y="609455"/>
            <a:ext cx="8823581" cy="61390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39D0BA8-0F70-27C1-B0A9-A362043ABD21}"/>
              </a:ext>
            </a:extLst>
          </p:cNvPr>
          <p:cNvSpPr txBox="1"/>
          <p:nvPr/>
        </p:nvSpPr>
        <p:spPr>
          <a:xfrm>
            <a:off x="9587698" y="1494640"/>
            <a:ext cx="2494811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 G-banded chromosomes from EA.hy926 cell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Arrangement of chromosomes based on their size, shape, and banding pattern following conventional cytogenetic analysis of 15 metaphase spreads from EA.hy926 cells. Mar, marker chromosomes.  </a:t>
            </a:r>
          </a:p>
        </p:txBody>
      </p:sp>
    </p:spTree>
    <p:extLst>
      <p:ext uri="{BB962C8B-B14F-4D97-AF65-F5344CB8AC3E}">
        <p14:creationId xmlns:p14="http://schemas.microsoft.com/office/powerpoint/2010/main" val="2814217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802B5E6-C035-B355-3A46-435EFCE7E875}"/>
              </a:ext>
            </a:extLst>
          </p:cNvPr>
          <p:cNvSpPr txBox="1"/>
          <p:nvPr/>
        </p:nvSpPr>
        <p:spPr>
          <a:xfrm>
            <a:off x="9151688" y="2099568"/>
            <a:ext cx="267336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 Classified SKY image of der(12)t(8;12) in EA.hy926 cells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wenty four out of 50 cells show this translocation.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87A582-8FA5-17D3-FBA4-D34876DBCE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45" t="4898" r="70735" b="19059"/>
          <a:stretch/>
        </p:blipFill>
        <p:spPr>
          <a:xfrm>
            <a:off x="1232806" y="128311"/>
            <a:ext cx="7478487" cy="66013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12442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3B07F2-5F1D-4289-23D4-AAD0398CB16A}"/>
              </a:ext>
            </a:extLst>
          </p:cNvPr>
          <p:cNvSpPr txBox="1"/>
          <p:nvPr/>
        </p:nvSpPr>
        <p:spPr>
          <a:xfrm>
            <a:off x="8806649" y="2554399"/>
            <a:ext cx="3080551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 Classified SKY image of der(12)t(12;21) in EA.hy926 cells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wenty six out of 50 cells show this translocation.</a:t>
            </a:r>
            <a:endParaRPr lang="en-US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4E876156-59C2-562E-99C2-41714191717D}"/>
              </a:ext>
            </a:extLst>
          </p:cNvPr>
          <p:cNvGrpSpPr/>
          <p:nvPr/>
        </p:nvGrpSpPr>
        <p:grpSpPr>
          <a:xfrm>
            <a:off x="935180" y="244929"/>
            <a:ext cx="7315937" cy="6249520"/>
            <a:chOff x="935180" y="244929"/>
            <a:chExt cx="7315937" cy="624952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6F59CE3-8B9A-2266-EE07-32643CDE73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371" t="5067" r="71250" b="22823"/>
            <a:stretch/>
          </p:blipFill>
          <p:spPr>
            <a:xfrm>
              <a:off x="935180" y="244929"/>
              <a:ext cx="7315937" cy="6249520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B26FD8D1-5165-0B08-715E-10B5706C99CA}"/>
                </a:ext>
              </a:extLst>
            </p:cNvPr>
            <p:cNvSpPr/>
            <p:nvPr/>
          </p:nvSpPr>
          <p:spPr>
            <a:xfrm>
              <a:off x="6962215" y="2554399"/>
              <a:ext cx="376517" cy="24526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C8EFD86C-3CD0-E029-F466-70B20966CC48}"/>
                </a:ext>
              </a:extLst>
            </p:cNvPr>
            <p:cNvSpPr/>
            <p:nvPr/>
          </p:nvSpPr>
          <p:spPr>
            <a:xfrm>
              <a:off x="6962215" y="4343757"/>
              <a:ext cx="376517" cy="30330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196684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6232B6E-6EBC-A9AA-5CF8-487AEDC8BC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7406071"/>
              </p:ext>
            </p:extLst>
          </p:nvPr>
        </p:nvGraphicFramePr>
        <p:xfrm>
          <a:off x="311150" y="349250"/>
          <a:ext cx="11764963" cy="6343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3" imgW="5956042" imgH="3206451" progId="Word.Document.12">
                  <p:embed/>
                </p:oleObj>
              </mc:Choice>
              <mc:Fallback>
                <p:oleObj name="Document" r:id="rId3" imgW="5956042" imgH="3206451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1150" y="349250"/>
                        <a:ext cx="11764963" cy="6343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E70ACD2-F374-95FC-6CD0-1F23AE472901}"/>
              </a:ext>
            </a:extLst>
          </p:cNvPr>
          <p:cNvSpPr txBox="1"/>
          <p:nvPr/>
        </p:nvSpPr>
        <p:spPr>
          <a:xfrm>
            <a:off x="206405" y="6211669"/>
            <a:ext cx="1186722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800" b="1" u="none" strike="noStrike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800" b="1" u="none" strike="noStrike"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800" b="1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Comparison of 15 G-banded metaphase spreads with quantification of copy number for each chromosome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, marker chromosomes; Mo, modal chromosome numb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2439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0</Words>
  <Application>Microsoft Office PowerPoint</Application>
  <PresentationFormat>Widescreen</PresentationFormat>
  <Paragraphs>46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hak, Rupak</dc:creator>
  <cp:lastModifiedBy>MDPI</cp:lastModifiedBy>
  <cp:revision>4</cp:revision>
  <dcterms:created xsi:type="dcterms:W3CDTF">2024-06-13T15:07:19Z</dcterms:created>
  <dcterms:modified xsi:type="dcterms:W3CDTF">2024-07-20T09:15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6-13T15:14:15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2d7f5ee4-5785-4bb8-ba45-cedcfc4d9502</vt:lpwstr>
  </property>
  <property fmtid="{D5CDD505-2E9C-101B-9397-08002B2CF9AE}" pid="8" name="MSIP_Label_8ca390d5-a4f3-448c-8368-24080179bc53_ContentBits">
    <vt:lpwstr>0</vt:lpwstr>
  </property>
</Properties>
</file>